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56" r:id="rId2"/>
    <p:sldId id="257" r:id="rId3"/>
    <p:sldId id="258" r:id="rId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50" d="100"/>
          <a:sy n="50" d="100"/>
        </p:scale>
        <p:origin x="867" y="21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2DC3B70-8F23-433B-9BD6-ED5D38B351D5}" type="datetimeFigureOut">
              <a:rPr lang="en-AU" smtClean="0"/>
              <a:t>12/01/2017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18D2255-1696-499B-9E51-94EDF6ED2F5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42059199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18D2255-1696-499B-9E51-94EDF6ED2F5D}" type="slidenum">
              <a:rPr lang="en-AU" smtClean="0"/>
              <a:t>3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90681947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2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2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2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4.wdp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tiff"/><Relationship Id="rId5" Type="http://schemas.microsoft.com/office/2007/relationships/hdphoto" Target="../media/hdphoto5.wdp"/><Relationship Id="rId4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8" Type="http://schemas.microsoft.com/office/2007/relationships/hdphoto" Target="../media/hdphoto8.wdp"/><Relationship Id="rId3" Type="http://schemas.openxmlformats.org/officeDocument/2006/relationships/image" Target="../media/image7.png"/><Relationship Id="rId7" Type="http://schemas.openxmlformats.org/officeDocument/2006/relationships/image" Target="../media/image9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microsoft.com/office/2007/relationships/hdphoto" Target="../media/hdphoto7.wdp"/><Relationship Id="rId5" Type="http://schemas.openxmlformats.org/officeDocument/2006/relationships/image" Target="../media/image8.png"/><Relationship Id="rId4" Type="http://schemas.microsoft.com/office/2007/relationships/hdphoto" Target="../media/hdphoto6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283923" y="1244885"/>
            <a:ext cx="8588509" cy="2553447"/>
            <a:chOff x="283923" y="1244885"/>
            <a:chExt cx="8588509" cy="2553447"/>
          </a:xfrm>
        </p:grpSpPr>
        <p:pic>
          <p:nvPicPr>
            <p:cNvPr id="1026" name="Picture 2" descr="P:\Selected pic of SEM\ZUG 293\ZUG_old_adaxial 1.tif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50000"/>
                      </a14:imgEffect>
                      <a14:imgEffect>
                        <a14:brightnessContrast bright="-2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83923" y="1244885"/>
              <a:ext cx="2807751" cy="210581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27" name="Picture 3" descr="P:\Selected pic of SEM\ZUG 293\ZUG_M_adaxial 2.tif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 bwMode="auto">
            <a:xfrm>
              <a:off x="3154085" y="1244885"/>
              <a:ext cx="2835829" cy="212687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28" name="Picture 4" descr="P:\Selected pic of SEM\ZUG 293\ZUG_flag_adaxial 2.tif"/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064681" y="1265943"/>
              <a:ext cx="2807751" cy="210581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" name="TextBox 1"/>
            <p:cNvSpPr txBox="1"/>
            <p:nvPr/>
          </p:nvSpPr>
          <p:spPr>
            <a:xfrm>
              <a:off x="762000" y="3429000"/>
              <a:ext cx="16764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Old leaf</a:t>
              </a:r>
              <a:endParaRPr lang="en-AU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" name="TextBox 2"/>
            <p:cNvSpPr txBox="1"/>
            <p:nvPr/>
          </p:nvSpPr>
          <p:spPr>
            <a:xfrm>
              <a:off x="3581400" y="3429000"/>
              <a:ext cx="19812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ntermediate</a:t>
              </a:r>
              <a:r>
                <a:rPr lang="en-AU" dirty="0" smtClean="0"/>
                <a:t> leaf</a:t>
              </a:r>
              <a:endParaRPr lang="en-AU" dirty="0"/>
            </a:p>
          </p:txBody>
        </p:sp>
        <p:sp>
          <p:nvSpPr>
            <p:cNvPr id="4" name="TextBox 3"/>
            <p:cNvSpPr txBox="1"/>
            <p:nvPr/>
          </p:nvSpPr>
          <p:spPr>
            <a:xfrm>
              <a:off x="6781800" y="3418114"/>
              <a:ext cx="18288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lag leaf</a:t>
              </a:r>
              <a:endParaRPr lang="en-AU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6" name="TextBox 5"/>
          <p:cNvSpPr txBox="1"/>
          <p:nvPr/>
        </p:nvSpPr>
        <p:spPr>
          <a:xfrm>
            <a:off x="8077200" y="228600"/>
            <a:ext cx="533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 smtClean="0"/>
              <a:t>A</a:t>
            </a:r>
            <a:endParaRPr lang="en-AU" dirty="0"/>
          </a:p>
        </p:txBody>
      </p:sp>
      <p:sp>
        <p:nvSpPr>
          <p:cNvPr id="7" name="TextBox 6"/>
          <p:cNvSpPr txBox="1"/>
          <p:nvPr/>
        </p:nvSpPr>
        <p:spPr>
          <a:xfrm>
            <a:off x="283923" y="304800"/>
            <a:ext cx="4288077" cy="381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/>
              <a:t>ZUG293 </a:t>
            </a:r>
          </a:p>
        </p:txBody>
      </p:sp>
    </p:spTree>
    <p:extLst>
      <p:ext uri="{BB962C8B-B14F-4D97-AF65-F5344CB8AC3E}">
        <p14:creationId xmlns:p14="http://schemas.microsoft.com/office/powerpoint/2010/main" val="261776400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267570" y="1895974"/>
            <a:ext cx="8532180" cy="2664358"/>
            <a:chOff x="267570" y="1895974"/>
            <a:chExt cx="8532180" cy="2664358"/>
          </a:xfrm>
        </p:grpSpPr>
        <p:pic>
          <p:nvPicPr>
            <p:cNvPr id="2050" name="Picture 2" descr="P:\Selected pic of SEM\TX\TX_old_adaxial 2.tif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-25000"/>
                      </a14:imgEffect>
                      <a14:imgEffect>
                        <a14:brightnessContrast bright="-2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67570" y="1902505"/>
              <a:ext cx="2779951" cy="208496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051" name="Picture 3" descr="P:\Selected pic of SEM\TX\TX_M_adaxial 2.tif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sharpenSoften amount="-25000"/>
                      </a14:imgEffect>
                      <a14:imgEffect>
                        <a14:brightnessContrast bright="-2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141618" y="1895974"/>
              <a:ext cx="2779951" cy="208496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052" name="Picture 4" descr="P:\Selected pic of SEM\TX\TX_Flag_adaxial 2.tif"/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019799" y="1902505"/>
              <a:ext cx="2779951" cy="208496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" name="TextBox 1"/>
            <p:cNvSpPr txBox="1"/>
            <p:nvPr/>
          </p:nvSpPr>
          <p:spPr>
            <a:xfrm>
              <a:off x="990600" y="4191000"/>
              <a:ext cx="15240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Old leaf</a:t>
              </a:r>
              <a:endParaRPr lang="en-AU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" name="TextBox 2"/>
            <p:cNvSpPr txBox="1"/>
            <p:nvPr/>
          </p:nvSpPr>
          <p:spPr>
            <a:xfrm>
              <a:off x="3505200" y="4191000"/>
              <a:ext cx="22098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ntermediate</a:t>
              </a:r>
              <a:r>
                <a:rPr lang="en-AU" dirty="0" smtClean="0"/>
                <a:t> leaf</a:t>
              </a:r>
              <a:endParaRPr lang="en-AU" dirty="0"/>
            </a:p>
          </p:txBody>
        </p:sp>
        <p:sp>
          <p:nvSpPr>
            <p:cNvPr id="4" name="TextBox 3"/>
            <p:cNvSpPr txBox="1"/>
            <p:nvPr/>
          </p:nvSpPr>
          <p:spPr>
            <a:xfrm>
              <a:off x="6477000" y="4191000"/>
              <a:ext cx="20574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lag</a:t>
              </a:r>
              <a:r>
                <a:rPr lang="en-AU" dirty="0" smtClean="0"/>
                <a:t> leaf</a:t>
              </a:r>
              <a:endParaRPr lang="en-AU" dirty="0"/>
            </a:p>
          </p:txBody>
        </p:sp>
      </p:grpSp>
      <p:sp>
        <p:nvSpPr>
          <p:cNvPr id="6" name="TextBox 5"/>
          <p:cNvSpPr txBox="1"/>
          <p:nvPr/>
        </p:nvSpPr>
        <p:spPr>
          <a:xfrm>
            <a:off x="7924800" y="304800"/>
            <a:ext cx="8749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 smtClean="0"/>
              <a:t>B</a:t>
            </a:r>
            <a:endParaRPr lang="en-AU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457200"/>
            <a:ext cx="3733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 smtClean="0"/>
              <a:t>TX9425</a:t>
            </a:r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217933578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195945" y="1938863"/>
            <a:ext cx="8687992" cy="2666891"/>
            <a:chOff x="195945" y="1938863"/>
            <a:chExt cx="8687992" cy="2666891"/>
          </a:xfrm>
        </p:grpSpPr>
        <p:pic>
          <p:nvPicPr>
            <p:cNvPr id="3074" name="Picture 2" descr="P:\Selected pic of SEM\Gairdner\Gr_old_adaxial 2.tif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-2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5945" y="1938865"/>
              <a:ext cx="2835829" cy="212687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3075" name="Picture 3" descr="P:\Selected pic of SEM\Gairdner\Gr_M_adaxial 1.tif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-2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126381" y="1938864"/>
              <a:ext cx="2835829" cy="212687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3076" name="Picture 4" descr="P:\Selected pic of SEM\Gairdner\Gr_flag_adaxial 2.tif"/>
            <p:cNvPicPr>
              <a:picLocks noChangeAspect="1" noChangeArrowheads="1"/>
            </p:cNvPicPr>
            <p:nvPr/>
          </p:nvPicPr>
          <p:blipFill>
            <a:blip r:embed="rId7" cstate="print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-2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048108" y="1938863"/>
              <a:ext cx="2835829" cy="212687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" name="TextBox 1"/>
            <p:cNvSpPr txBox="1"/>
            <p:nvPr/>
          </p:nvSpPr>
          <p:spPr>
            <a:xfrm>
              <a:off x="533400" y="4267200"/>
              <a:ext cx="20574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Old leaf</a:t>
              </a:r>
              <a:endParaRPr lang="en-AU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" name="TextBox 2"/>
            <p:cNvSpPr txBox="1"/>
            <p:nvPr/>
          </p:nvSpPr>
          <p:spPr>
            <a:xfrm>
              <a:off x="3429000" y="4255532"/>
              <a:ext cx="23622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ntermediate leaf</a:t>
              </a:r>
              <a:endParaRPr lang="en-AU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" name="TextBox 3"/>
            <p:cNvSpPr txBox="1"/>
            <p:nvPr/>
          </p:nvSpPr>
          <p:spPr>
            <a:xfrm>
              <a:off x="6726388" y="4255532"/>
              <a:ext cx="21336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lag leaf</a:t>
              </a:r>
              <a:endParaRPr lang="en-AU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6" name="TextBox 5"/>
          <p:cNvSpPr txBox="1"/>
          <p:nvPr/>
        </p:nvSpPr>
        <p:spPr>
          <a:xfrm>
            <a:off x="7924800" y="304800"/>
            <a:ext cx="609600" cy="381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 smtClean="0"/>
              <a:t>C</a:t>
            </a:r>
            <a:endParaRPr lang="en-AU" dirty="0"/>
          </a:p>
        </p:txBody>
      </p:sp>
      <p:sp>
        <p:nvSpPr>
          <p:cNvPr id="7" name="TextBox 6"/>
          <p:cNvSpPr txBox="1"/>
          <p:nvPr/>
        </p:nvSpPr>
        <p:spPr>
          <a:xfrm>
            <a:off x="533400" y="457200"/>
            <a:ext cx="4572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 smtClean="0"/>
              <a:t>Gairdner </a:t>
            </a:r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1959091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9</TotalTime>
  <Words>25</Words>
  <Application>Microsoft Office PowerPoint</Application>
  <PresentationFormat>On-screen Show (4:3)</PresentationFormat>
  <Paragraphs>16</Paragraphs>
  <Slides>3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6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d Hasanuzzaman</dc:creator>
  <cp:lastModifiedBy>Sergey Shabala</cp:lastModifiedBy>
  <cp:revision>7</cp:revision>
  <dcterms:created xsi:type="dcterms:W3CDTF">2006-08-16T00:00:00Z</dcterms:created>
  <dcterms:modified xsi:type="dcterms:W3CDTF">2017-01-12T02:22:59Z</dcterms:modified>
</cp:coreProperties>
</file>